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328"/>
    <p:restoredTop sz="93945"/>
  </p:normalViewPr>
  <p:slideViewPr>
    <p:cSldViewPr snapToGrid="0" snapToObjects="1">
      <p:cViewPr>
        <p:scale>
          <a:sx n="69" d="100"/>
          <a:sy n="69" d="100"/>
        </p:scale>
        <p:origin x="33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450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38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55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194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669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14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3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159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64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719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95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444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15">
            <a:extLst>
              <a:ext uri="{FF2B5EF4-FFF2-40B4-BE49-F238E27FC236}">
                <a16:creationId xmlns:a16="http://schemas.microsoft.com/office/drawing/2014/main" id="{16DE7671-CA83-8E43-A105-C2112906FDB6}"/>
              </a:ext>
            </a:extLst>
          </p:cNvPr>
          <p:cNvPicPr/>
          <p:nvPr/>
        </p:nvPicPr>
        <p:blipFill rotWithShape="1">
          <a:blip r:embed="rId2"/>
          <a:srcRect l="81679"/>
          <a:stretch/>
        </p:blipFill>
        <p:spPr bwMode="auto">
          <a:xfrm>
            <a:off x="3847257" y="414675"/>
            <a:ext cx="890230" cy="307276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79B3890-A747-49CB-870C-CCF71E3E7DF0}"/>
              </a:ext>
            </a:extLst>
          </p:cNvPr>
          <p:cNvSpPr/>
          <p:nvPr/>
        </p:nvSpPr>
        <p:spPr>
          <a:xfrm>
            <a:off x="304800" y="3639712"/>
            <a:ext cx="4184073" cy="8672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CA" sz="11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:</a:t>
            </a:r>
            <a:r>
              <a:rPr lang="en-CA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ultiplex PCR virus detection for 3 hornet and 4 bee pool samples (Table S1). Five µl of PCR products were run in 4% agarose. Ladder 100bp is from Promega, the most intense band corresponds to a 500bp sized fragment. Arrows show expected fragment size corresponding to BQCV (536bp), ABPV (460), SBV (342bp), DWV (269bp)</a:t>
            </a:r>
            <a:endParaRPr lang="fr-FR" sz="11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6C03F750-CDB7-4DCA-9C27-3863B8933594}"/>
              </a:ext>
            </a:extLst>
          </p:cNvPr>
          <p:cNvGrpSpPr/>
          <p:nvPr/>
        </p:nvGrpSpPr>
        <p:grpSpPr>
          <a:xfrm>
            <a:off x="413374" y="6729"/>
            <a:ext cx="3327764" cy="3480711"/>
            <a:chOff x="4026993" y="512512"/>
            <a:chExt cx="4668890" cy="4278563"/>
          </a:xfrm>
        </p:grpSpPr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AA13F56F-6E28-4773-85B1-7B1701E1F980}"/>
                </a:ext>
              </a:extLst>
            </p:cNvPr>
            <p:cNvSpPr txBox="1"/>
            <p:nvPr/>
          </p:nvSpPr>
          <p:spPr>
            <a:xfrm>
              <a:off x="4082572" y="1256258"/>
              <a:ext cx="518177" cy="73713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Ladder</a:t>
              </a:r>
              <a:endParaRPr lang="fr-FR" sz="1200" dirty="0"/>
            </a:p>
          </p:txBody>
        </p:sp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97A57051-EBE5-4658-92AC-F59A22C4B4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87" r="8263"/>
            <a:stretch/>
          </p:blipFill>
          <p:spPr>
            <a:xfrm>
              <a:off x="4026993" y="2066925"/>
              <a:ext cx="4668890" cy="2724150"/>
            </a:xfrm>
            <a:prstGeom prst="rect">
              <a:avLst/>
            </a:prstGeom>
          </p:spPr>
        </p:pic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D0732E77-3E3E-4E0B-AE9F-575F7C57A84E}"/>
                </a:ext>
              </a:extLst>
            </p:cNvPr>
            <p:cNvSpPr txBox="1"/>
            <p:nvPr/>
          </p:nvSpPr>
          <p:spPr>
            <a:xfrm>
              <a:off x="4552548" y="563173"/>
              <a:ext cx="518177" cy="13973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bee-pool-142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EC823812-3B9C-44BB-8F80-D145BD61EFA3}"/>
                </a:ext>
              </a:extLst>
            </p:cNvPr>
            <p:cNvSpPr txBox="1"/>
            <p:nvPr/>
          </p:nvSpPr>
          <p:spPr>
            <a:xfrm>
              <a:off x="5067933" y="887785"/>
              <a:ext cx="518177" cy="110560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143-1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23CEF413-293D-44D4-B152-A35BA23AAECC}"/>
                </a:ext>
              </a:extLst>
            </p:cNvPr>
            <p:cNvSpPr txBox="1"/>
            <p:nvPr/>
          </p:nvSpPr>
          <p:spPr>
            <a:xfrm>
              <a:off x="5621138" y="666119"/>
              <a:ext cx="518177" cy="132727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144-2 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65A99BED-7193-4761-A145-CB99F8912AC8}"/>
                </a:ext>
              </a:extLst>
            </p:cNvPr>
            <p:cNvSpPr txBox="1"/>
            <p:nvPr/>
          </p:nvSpPr>
          <p:spPr>
            <a:xfrm>
              <a:off x="6111705" y="596060"/>
              <a:ext cx="518177" cy="13973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bee-pool-145 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1D87CE77-4713-4E0F-9840-DB4E9B490F80}"/>
                </a:ext>
              </a:extLst>
            </p:cNvPr>
            <p:cNvSpPr txBox="1"/>
            <p:nvPr/>
          </p:nvSpPr>
          <p:spPr>
            <a:xfrm>
              <a:off x="6575483" y="520783"/>
              <a:ext cx="518177" cy="146436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bee-pool-147 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E0C689BB-C7C7-40FE-B024-A115F083E135}"/>
                </a:ext>
              </a:extLst>
            </p:cNvPr>
            <p:cNvSpPr txBox="1"/>
            <p:nvPr/>
          </p:nvSpPr>
          <p:spPr>
            <a:xfrm>
              <a:off x="7110267" y="865196"/>
              <a:ext cx="518177" cy="110561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148-1 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CA30DE8C-68D3-41DE-9D77-1CED5B87CFA3}"/>
                </a:ext>
              </a:extLst>
            </p:cNvPr>
            <p:cNvSpPr txBox="1"/>
            <p:nvPr/>
          </p:nvSpPr>
          <p:spPr>
            <a:xfrm>
              <a:off x="7648484" y="512512"/>
              <a:ext cx="518177" cy="146436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/>
                <a:t>bee-pool-149 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BA3FD8AB-AFEE-4822-B54B-FC335AA0F0D6}"/>
                </a:ext>
              </a:extLst>
            </p:cNvPr>
            <p:cNvSpPr txBox="1"/>
            <p:nvPr/>
          </p:nvSpPr>
          <p:spPr>
            <a:xfrm>
              <a:off x="8176656" y="1256258"/>
              <a:ext cx="518177" cy="73713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200" dirty="0" err="1"/>
                <a:t>Ladder</a:t>
              </a:r>
              <a:endParaRPr lang="fr-FR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22798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4</TotalTime>
  <Words>80</Words>
  <Application>Microsoft Office PowerPoint</Application>
  <PresentationFormat>Format A4 (210 x 297 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ne Dalmon</cp:lastModifiedBy>
  <cp:revision>39</cp:revision>
  <dcterms:created xsi:type="dcterms:W3CDTF">2019-01-23T12:04:28Z</dcterms:created>
  <dcterms:modified xsi:type="dcterms:W3CDTF">2019-07-19T16:34:36Z</dcterms:modified>
</cp:coreProperties>
</file>